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76" r:id="rId3"/>
    <p:sldId id="275" r:id="rId4"/>
    <p:sldId id="270" r:id="rId5"/>
    <p:sldId id="277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F2E08FEA-E3D7-413B-B5AE-0BC2A9933BA2}">
          <p14:sldIdLst>
            <p14:sldId id="267"/>
            <p14:sldId id="276"/>
            <p14:sldId id="275"/>
            <p14:sldId id="270"/>
            <p14:sldId id="27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2" autoAdjust="0"/>
    <p:restoredTop sz="94660"/>
  </p:normalViewPr>
  <p:slideViewPr>
    <p:cSldViewPr snapToGrid="0">
      <p:cViewPr varScale="1">
        <p:scale>
          <a:sx n="98" d="100"/>
          <a:sy n="98" d="100"/>
        </p:scale>
        <p:origin x="3216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499"/>
            </a:lvl2pPr>
            <a:lvl3pPr marL="685742" indent="0" algn="ctr">
              <a:buNone/>
              <a:defRPr sz="1351"/>
            </a:lvl3pPr>
            <a:lvl4pPr marL="1028614" indent="0" algn="ctr">
              <a:buNone/>
              <a:defRPr sz="1200"/>
            </a:lvl4pPr>
            <a:lvl5pPr marL="1371485" indent="0" algn="ctr">
              <a:buNone/>
              <a:defRPr sz="1200"/>
            </a:lvl5pPr>
            <a:lvl6pPr marL="1714357" indent="0" algn="ctr">
              <a:buNone/>
              <a:defRPr sz="1200"/>
            </a:lvl6pPr>
            <a:lvl7pPr marL="2057227" indent="0" algn="ctr">
              <a:buNone/>
              <a:defRPr sz="1200"/>
            </a:lvl7pPr>
            <a:lvl8pPr marL="2400099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9734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051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471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0461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2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42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7279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588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2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5" indent="0">
              <a:buNone/>
              <a:defRPr sz="1200" b="1"/>
            </a:lvl5pPr>
            <a:lvl6pPr marL="1714357" indent="0">
              <a:buNone/>
              <a:defRPr sz="1200" b="1"/>
            </a:lvl6pPr>
            <a:lvl7pPr marL="2057227" indent="0">
              <a:buNone/>
              <a:defRPr sz="1200" b="1"/>
            </a:lvl7pPr>
            <a:lvl8pPr marL="2400099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2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5" indent="0">
              <a:buNone/>
              <a:defRPr sz="1200" b="1"/>
            </a:lvl5pPr>
            <a:lvl6pPr marL="1714357" indent="0">
              <a:buNone/>
              <a:defRPr sz="1200" b="1"/>
            </a:lvl6pPr>
            <a:lvl7pPr marL="2057227" indent="0">
              <a:buNone/>
              <a:defRPr sz="1200" b="1"/>
            </a:lvl7pPr>
            <a:lvl8pPr marL="2400099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63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0638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039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2" indent="0">
              <a:buNone/>
              <a:defRPr sz="900"/>
            </a:lvl3pPr>
            <a:lvl4pPr marL="1028614" indent="0">
              <a:buNone/>
              <a:defRPr sz="750"/>
            </a:lvl4pPr>
            <a:lvl5pPr marL="1371485" indent="0">
              <a:buNone/>
              <a:defRPr sz="750"/>
            </a:lvl5pPr>
            <a:lvl6pPr marL="1714357" indent="0">
              <a:buNone/>
              <a:defRPr sz="750"/>
            </a:lvl6pPr>
            <a:lvl7pPr marL="2057227" indent="0">
              <a:buNone/>
              <a:defRPr sz="750"/>
            </a:lvl7pPr>
            <a:lvl8pPr marL="2400099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789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72" indent="0">
              <a:buNone/>
              <a:defRPr sz="2100"/>
            </a:lvl2pPr>
            <a:lvl3pPr marL="685742" indent="0">
              <a:buNone/>
              <a:defRPr sz="1800"/>
            </a:lvl3pPr>
            <a:lvl4pPr marL="1028614" indent="0">
              <a:buNone/>
              <a:defRPr sz="1499"/>
            </a:lvl4pPr>
            <a:lvl5pPr marL="1371485" indent="0">
              <a:buNone/>
              <a:defRPr sz="1499"/>
            </a:lvl5pPr>
            <a:lvl6pPr marL="1714357" indent="0">
              <a:buNone/>
              <a:defRPr sz="1499"/>
            </a:lvl6pPr>
            <a:lvl7pPr marL="2057227" indent="0">
              <a:buNone/>
              <a:defRPr sz="1499"/>
            </a:lvl7pPr>
            <a:lvl8pPr marL="2400099" indent="0">
              <a:buNone/>
              <a:defRPr sz="1499"/>
            </a:lvl8pPr>
            <a:lvl9pPr marL="2742970" indent="0">
              <a:buNone/>
              <a:defRPr sz="1499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2" indent="0">
              <a:buNone/>
              <a:defRPr sz="900"/>
            </a:lvl3pPr>
            <a:lvl4pPr marL="1028614" indent="0">
              <a:buNone/>
              <a:defRPr sz="750"/>
            </a:lvl4pPr>
            <a:lvl5pPr marL="1371485" indent="0">
              <a:buNone/>
              <a:defRPr sz="750"/>
            </a:lvl5pPr>
            <a:lvl6pPr marL="1714357" indent="0">
              <a:buNone/>
              <a:defRPr sz="750"/>
            </a:lvl6pPr>
            <a:lvl7pPr marL="2057227" indent="0">
              <a:buNone/>
              <a:defRPr sz="750"/>
            </a:lvl7pPr>
            <a:lvl8pPr marL="2400099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674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2371C-296E-4E78-85D6-B517B25ED790}" type="datetimeFigureOut">
              <a:rPr kumimoji="1" lang="ja-JP" altLang="en-US" smtClean="0"/>
              <a:t>2022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BFBA7-4FB5-4DCA-B956-36853270BA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1353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2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8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1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3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2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2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42" algn="l" defTabSz="685742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2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5" algn="l" defTabSz="685742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7" algn="l" defTabSz="685742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7" algn="l" defTabSz="685742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9" algn="l" defTabSz="685742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2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C034904-D525-4EE6-988B-B7556F977CF3}"/>
              </a:ext>
            </a:extLst>
          </p:cNvPr>
          <p:cNvSpPr txBox="1"/>
          <p:nvPr/>
        </p:nvSpPr>
        <p:spPr>
          <a:xfrm>
            <a:off x="445998" y="6712614"/>
            <a:ext cx="23530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8B042D27-EB1B-447E-9418-FA82DE9BD165}"/>
              </a:ext>
            </a:extLst>
          </p:cNvPr>
          <p:cNvGraphicFramePr>
            <a:graphicFrameLocks noGrp="1"/>
          </p:cNvGraphicFramePr>
          <p:nvPr/>
        </p:nvGraphicFramePr>
        <p:xfrm>
          <a:off x="3948944" y="3846229"/>
          <a:ext cx="2324100" cy="167989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3884">
                  <a:extLst>
                    <a:ext uri="{9D8B030D-6E8A-4147-A177-3AD203B41FA5}">
                      <a16:colId xmlns:a16="http://schemas.microsoft.com/office/drawing/2014/main" val="3230121087"/>
                    </a:ext>
                  </a:extLst>
                </a:gridCol>
                <a:gridCol w="715108">
                  <a:extLst>
                    <a:ext uri="{9D8B030D-6E8A-4147-A177-3AD203B41FA5}">
                      <a16:colId xmlns:a16="http://schemas.microsoft.com/office/drawing/2014/main" val="4063096205"/>
                    </a:ext>
                  </a:extLst>
                </a:gridCol>
                <a:gridCol w="715108">
                  <a:extLst>
                    <a:ext uri="{9D8B030D-6E8A-4147-A177-3AD203B41FA5}">
                      <a16:colId xmlns:a16="http://schemas.microsoft.com/office/drawing/2014/main" val="3418486281"/>
                    </a:ext>
                  </a:extLst>
                </a:gridCol>
              </a:tblGrid>
              <a:tr h="382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b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opy/well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5002713"/>
                  </a:ext>
                </a:extLst>
              </a:tr>
              <a:tr h="18534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,00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1076012"/>
                  </a:ext>
                </a:extLst>
              </a:tr>
              <a:tr h="18534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00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7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7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1088666"/>
                  </a:ext>
                </a:extLst>
              </a:tr>
              <a:tr h="18534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7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7594117"/>
                  </a:ext>
                </a:extLst>
              </a:tr>
              <a:tr h="18534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4726505"/>
                  </a:ext>
                </a:extLst>
              </a:tr>
              <a:tr h="18534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9639723"/>
                  </a:ext>
                </a:extLst>
              </a:tr>
              <a:tr h="18534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9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2436521"/>
                  </a:ext>
                </a:extLst>
              </a:tr>
              <a:tr h="18534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10800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7287720"/>
                  </a:ext>
                </a:extLst>
              </a:tr>
            </a:tbl>
          </a:graphicData>
        </a:graphic>
      </p:graphicFrame>
      <p:pic>
        <p:nvPicPr>
          <p:cNvPr id="7" name="図 6">
            <a:extLst>
              <a:ext uri="{FF2B5EF4-FFF2-40B4-BE49-F238E27FC236}">
                <a16:creationId xmlns:a16="http://schemas.microsoft.com/office/drawing/2014/main" id="{137C836A-0395-4056-B82F-CD8FB3F6B1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5569" y="3274060"/>
            <a:ext cx="3219450" cy="307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4257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879092F-E148-47B3-B433-8EDE87CE47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09514"/>
            <a:ext cx="6858000" cy="3195907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DB3E719-15D6-4C71-9DF3-67F3522939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008315"/>
            <a:ext cx="6858000" cy="319029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237CB5F-A178-01DD-D18C-99C0AEBB6575}"/>
              </a:ext>
            </a:extLst>
          </p:cNvPr>
          <p:cNvSpPr txBox="1"/>
          <p:nvPr/>
        </p:nvSpPr>
        <p:spPr>
          <a:xfrm>
            <a:off x="199564" y="8296431"/>
            <a:ext cx="23530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42E7D80-4586-54AC-649B-B8586C05A851}"/>
              </a:ext>
            </a:extLst>
          </p:cNvPr>
          <p:cNvSpPr txBox="1"/>
          <p:nvPr/>
        </p:nvSpPr>
        <p:spPr>
          <a:xfrm>
            <a:off x="199563" y="960491"/>
            <a:ext cx="3646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DB737DE-DFFF-5D26-1CDB-98311BF1616D}"/>
              </a:ext>
            </a:extLst>
          </p:cNvPr>
          <p:cNvSpPr txBox="1"/>
          <p:nvPr/>
        </p:nvSpPr>
        <p:spPr>
          <a:xfrm>
            <a:off x="199562" y="4654334"/>
            <a:ext cx="3646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545394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31652A0-043F-4C04-8A70-7D9E98E312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89505"/>
            <a:ext cx="6858000" cy="312328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F355CD38-B289-4E2B-8C63-0760DBC65C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026094"/>
            <a:ext cx="6858000" cy="312879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D040932-FDC4-4DA8-957D-A461CC36A206}"/>
              </a:ext>
            </a:extLst>
          </p:cNvPr>
          <p:cNvSpPr txBox="1"/>
          <p:nvPr/>
        </p:nvSpPr>
        <p:spPr>
          <a:xfrm>
            <a:off x="199563" y="960491"/>
            <a:ext cx="3646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45546BE-A940-AD95-4E16-EA24DAA96CA9}"/>
              </a:ext>
            </a:extLst>
          </p:cNvPr>
          <p:cNvSpPr txBox="1"/>
          <p:nvPr/>
        </p:nvSpPr>
        <p:spPr>
          <a:xfrm>
            <a:off x="199562" y="4654334"/>
            <a:ext cx="3646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33DB8AE-E632-355C-88C1-A3AB501B49E4}"/>
              </a:ext>
            </a:extLst>
          </p:cNvPr>
          <p:cNvSpPr txBox="1"/>
          <p:nvPr/>
        </p:nvSpPr>
        <p:spPr>
          <a:xfrm>
            <a:off x="199564" y="8296431"/>
            <a:ext cx="30040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(continued)</a:t>
            </a:r>
          </a:p>
        </p:txBody>
      </p:sp>
    </p:spTree>
    <p:extLst>
      <p:ext uri="{BB962C8B-B14F-4D97-AF65-F5344CB8AC3E}">
        <p14:creationId xmlns:p14="http://schemas.microsoft.com/office/powerpoint/2010/main" val="7558163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B307710-AB6E-435E-8C0F-5FC2539919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96" y="1122138"/>
            <a:ext cx="6858000" cy="3589076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09CB67B-D889-4CEB-A823-9BF769B682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96" y="5074852"/>
            <a:ext cx="6858000" cy="3589076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D24AF66-86C7-4E43-A38A-E9D8B54CF1A4}"/>
              </a:ext>
            </a:extLst>
          </p:cNvPr>
          <p:cNvSpPr txBox="1"/>
          <p:nvPr/>
        </p:nvSpPr>
        <p:spPr>
          <a:xfrm>
            <a:off x="4889770" y="1045012"/>
            <a:ext cx="10342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1973</a:t>
            </a:r>
          </a:p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2047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DB08AB3-5F82-42F1-B4BC-4D6FC175FE24}"/>
              </a:ext>
            </a:extLst>
          </p:cNvPr>
          <p:cNvSpPr txBox="1"/>
          <p:nvPr/>
        </p:nvSpPr>
        <p:spPr>
          <a:xfrm>
            <a:off x="4889770" y="5034777"/>
            <a:ext cx="10342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1539</a:t>
            </a:r>
          </a:p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3701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8A7219A-ABC6-B337-389A-505D0FF7D6C9}"/>
              </a:ext>
            </a:extLst>
          </p:cNvPr>
          <p:cNvSpPr txBox="1"/>
          <p:nvPr/>
        </p:nvSpPr>
        <p:spPr>
          <a:xfrm>
            <a:off x="199563" y="960491"/>
            <a:ext cx="3646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AD295D2-2C41-BE3A-8835-8CC07761431A}"/>
              </a:ext>
            </a:extLst>
          </p:cNvPr>
          <p:cNvSpPr txBox="1"/>
          <p:nvPr/>
        </p:nvSpPr>
        <p:spPr>
          <a:xfrm>
            <a:off x="199562" y="4946434"/>
            <a:ext cx="3646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9823DDD-7A8F-9513-2E65-C2AA34A941D1}"/>
              </a:ext>
            </a:extLst>
          </p:cNvPr>
          <p:cNvSpPr txBox="1"/>
          <p:nvPr/>
        </p:nvSpPr>
        <p:spPr>
          <a:xfrm>
            <a:off x="199562" y="8925966"/>
            <a:ext cx="235308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5930976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FCDC5506-7BB4-1DBF-42A4-BCDADBBCF8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19" y="5104223"/>
            <a:ext cx="6858000" cy="346972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09F153D-8B34-04CD-FFC7-DBB6598B441C}"/>
              </a:ext>
            </a:extLst>
          </p:cNvPr>
          <p:cNvSpPr txBox="1"/>
          <p:nvPr/>
        </p:nvSpPr>
        <p:spPr>
          <a:xfrm>
            <a:off x="199563" y="960491"/>
            <a:ext cx="3646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313FF2E-D87B-9B34-769A-EE29A7B18363}"/>
              </a:ext>
            </a:extLst>
          </p:cNvPr>
          <p:cNvSpPr txBox="1"/>
          <p:nvPr/>
        </p:nvSpPr>
        <p:spPr>
          <a:xfrm>
            <a:off x="199563" y="4974847"/>
            <a:ext cx="3646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5816328-54A1-E57B-1F5E-159A74F9238A}"/>
              </a:ext>
            </a:extLst>
          </p:cNvPr>
          <p:cNvSpPr txBox="1"/>
          <p:nvPr/>
        </p:nvSpPr>
        <p:spPr>
          <a:xfrm>
            <a:off x="199563" y="8859423"/>
            <a:ext cx="30040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(continued)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A47528B-8291-CADA-8324-0B579566AC54}"/>
              </a:ext>
            </a:extLst>
          </p:cNvPr>
          <p:cNvSpPr txBox="1"/>
          <p:nvPr/>
        </p:nvSpPr>
        <p:spPr>
          <a:xfrm>
            <a:off x="4889770" y="1045012"/>
            <a:ext cx="10342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4088</a:t>
            </a:r>
          </a:p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0133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D446AF8-C31A-B2ED-DB98-28DCD76E333E}"/>
              </a:ext>
            </a:extLst>
          </p:cNvPr>
          <p:cNvSpPr txBox="1"/>
          <p:nvPr/>
        </p:nvSpPr>
        <p:spPr>
          <a:xfrm>
            <a:off x="4889770" y="5104223"/>
            <a:ext cx="10342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1652</a:t>
            </a:r>
          </a:p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3356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61482A82-E9B2-6D48-DD69-A4F67A2B90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60546"/>
            <a:ext cx="6809362" cy="34698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8840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6</TotalTime>
  <Words>78</Words>
  <Application>Microsoft Office PowerPoint</Application>
  <PresentationFormat>A4 210 x 297 mm</PresentationFormat>
  <Paragraphs>44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谷本 佳彦</dc:creator>
  <cp:lastModifiedBy>607_win</cp:lastModifiedBy>
  <cp:revision>46</cp:revision>
  <dcterms:created xsi:type="dcterms:W3CDTF">2021-08-23T03:50:18Z</dcterms:created>
  <dcterms:modified xsi:type="dcterms:W3CDTF">2022-05-09T06:18:51Z</dcterms:modified>
</cp:coreProperties>
</file>